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7545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B06DD9-3949-42A5-BE90-DB097A6DEF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B85852-11A3-4930-BB74-F387CE4E88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F1AA0-48EB-41B4-B1EF-63D3998EAF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81E79-C6A5-43DC-9725-47CBEC1129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9B5BC-21BC-484B-8039-579FF65C74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A8A1FA-1A07-47AA-BC79-58904F9E55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F0D3C3-A5C3-4D40-AD4A-E9993FACE7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04CF30-03D8-4C7D-848F-7BCCE46269A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6F105E-4F93-4172-BC35-ACB1A6A3F4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70C180-4119-4D8D-80A3-0E9CEA9AB1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C81EB9-405D-40FB-B6F3-C1CCBEBA60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C6FAC-6600-4714-A2D5-16B67E6D0E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2AD699-6AFA-4E1F-8390-3CD5B9E076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69800" y="2986200"/>
            <a:ext cx="827748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69800" y="3522600"/>
            <a:ext cx="827748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69800" y="4075200"/>
            <a:ext cx="827748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69800" y="2443320"/>
            <a:ext cx="8277480" cy="28728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513120" y="2463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038200" y="2463840"/>
            <a:ext cx="40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g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457880" y="246384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Gend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2518920" y="234936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llection da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803560" y="2463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546800" y="217800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d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68360" y="2716200"/>
            <a:ext cx="82771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68360" y="2135160"/>
            <a:ext cx="82771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68360" y="4362480"/>
            <a:ext cx="82771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68360" y="4086360"/>
            <a:ext cx="8277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405320" y="2440080"/>
            <a:ext cx="10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5707080" y="2440080"/>
            <a:ext cx="3044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383240" y="2463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" name=""/>
          <p:cNvGrpSpPr/>
          <p:nvPr/>
        </p:nvGrpSpPr>
        <p:grpSpPr>
          <a:xfrm>
            <a:off x="719640" y="2746440"/>
            <a:ext cx="7663680" cy="1307880"/>
            <a:chOff x="719640" y="2746440"/>
            <a:chExt cx="7663680" cy="1307880"/>
          </a:xfrm>
        </p:grpSpPr>
        <p:sp>
          <p:nvSpPr>
            <p:cNvPr id="59" name=""/>
            <p:cNvSpPr/>
            <p:nvPr/>
          </p:nvSpPr>
          <p:spPr>
            <a:xfrm>
              <a:off x="720000" y="356544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4527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720000" y="329256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3450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20000" y="383868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5056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19640" y="3019320"/>
              <a:ext cx="1233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2752/2009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521080" y="3292560"/>
              <a:ext cx="75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9 Apr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521080" y="3019320"/>
              <a:ext cx="75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4 Mar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521080" y="3838680"/>
              <a:ext cx="75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6 Jun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521440" y="3565440"/>
              <a:ext cx="775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8 May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720000" y="2746440"/>
              <a:ext cx="1204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A/Egypt/N00606/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521080" y="2746440"/>
              <a:ext cx="75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7 Feb 200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482720" y="3292560"/>
              <a:ext cx="26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482720" y="383868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4482720" y="3565440"/>
              <a:ext cx="26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046840" y="3292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046840" y="3838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6511320" y="3292560"/>
              <a:ext cx="58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ele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511320" y="3019320"/>
              <a:ext cx="58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ele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511320" y="3838680"/>
              <a:ext cx="58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ele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511320" y="3565440"/>
              <a:ext cx="58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ele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511320" y="2746440"/>
              <a:ext cx="583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Dele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5802120" y="329256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802120" y="301932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802120" y="383868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802120" y="356544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802120" y="2746440"/>
              <a:ext cx="25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574440" y="274644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574440" y="301932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574440" y="329256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574440" y="356544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574440" y="3838680"/>
              <a:ext cx="526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Huma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482720" y="301932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046840" y="30193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482720" y="2746440"/>
              <a:ext cx="266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046840" y="2746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046840" y="3565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7381440" y="329256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7381440" y="301932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7381440" y="383868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7381440" y="356544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7381440" y="2746440"/>
              <a:ext cx="243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8173800" y="329256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8173800" y="301932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8173800" y="383868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8173800" y="356544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8173800" y="2746440"/>
              <a:ext cx="209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8175240" y="2463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717840" y="4110120"/>
            <a:ext cx="1972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ther H5N1 viruses isolated in Egyp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511680" y="41101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5802120" y="41101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7381800" y="4110120"/>
            <a:ext cx="20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8173800" y="41101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392040" y="1716120"/>
            <a:ext cx="485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able S5. Properties of H5N1 influenza viruses in sublineage BII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708120" y="2349360"/>
            <a:ext cx="82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Virus strain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438600" y="2178000"/>
            <a:ext cx="1454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mino acid at HA residu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3574800" y="23493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96720" y="4514760"/>
            <a:ext cx="558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a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equence data from the National Center for Biotechnology Information database in addition to our sequence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401040" y="5157720"/>
            <a:ext cx="95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d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5 numbering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403560" y="4943520"/>
            <a:ext cx="121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age in year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401040" y="4729320"/>
            <a:ext cx="263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Virus strains are listed in order of collection dat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1T05:02:37Z</dcterms:created>
  <dc:creator>nabe</dc:creator>
  <dc:description/>
  <dc:language>en-US</dc:language>
  <cp:lastModifiedBy>nabe</cp:lastModifiedBy>
  <dcterms:modified xsi:type="dcterms:W3CDTF">2011-03-25T08:11:57Z</dcterms:modified>
  <cp:revision>15</cp:revision>
  <dc:subject/>
  <dc:title>スライド 1</dc:title>
</cp:coreProperties>
</file>